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58" r:id="rId3"/>
    <p:sldId id="259" r:id="rId4"/>
    <p:sldId id="260" r:id="rId5"/>
    <p:sldId id="261" r:id="rId6"/>
    <p:sldId id="262" r:id="rId7"/>
    <p:sldId id="263" r:id="rId8"/>
    <p:sldId id="264" r:id="rId9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58" d="100"/>
          <a:sy n="58" d="100"/>
        </p:scale>
        <p:origin x="1932" y="6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944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2013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0077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59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05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1232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547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27172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48444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3607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07798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D70928-0581-487C-BF01-AD815A7EA6AA}" type="datetimeFigureOut">
              <a:rPr lang="en-US" smtClean="0"/>
              <a:t>10/2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D0F543-5B61-4A0C-8831-07687FCBDB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73718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16"/>
          <p:cNvSpPr/>
          <p:nvPr/>
        </p:nvSpPr>
        <p:spPr>
          <a:xfrm>
            <a:off x="0" y="-1"/>
            <a:ext cx="685800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</a:pPr>
            <a:r>
              <a:rPr lang="en-US" sz="1000" b="1" dirty="0" smtClean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S4 </a:t>
            </a:r>
            <a:r>
              <a:rPr lang="en-US" sz="1000" b="1" dirty="0">
                <a:latin typeface="Arial" panose="020B0604020202020204" pitchFamily="34" charset="0"/>
                <a:ea typeface="SimSun" panose="02010600030101010101" pitchFamily="2" charset="-122"/>
                <a:cs typeface="Arial" panose="020B0604020202020204" pitchFamily="34" charset="0"/>
              </a:rPr>
              <a:t>Fig. </a:t>
            </a:r>
            <a:r>
              <a:rPr lang="en-US" sz="1000" b="1" dirty="0"/>
              <a:t>HIF-1 direct targets </a:t>
            </a:r>
            <a:r>
              <a:rPr lang="en-US" sz="1000" b="1" dirty="0" err="1"/>
              <a:t>ChIP-seq</a:t>
            </a:r>
            <a:r>
              <a:rPr lang="en-US" sz="1000" b="1"/>
              <a:t> IGB signals </a:t>
            </a:r>
            <a:r>
              <a:rPr lang="en-US" sz="1000" b="1" smtClean="0">
                <a:latin typeface="Arial" panose="020B0604020202020204" pitchFamily="34" charset="0"/>
                <a:cs typeface="Arial" panose="020B0604020202020204" pitchFamily="34" charset="0"/>
              </a:rPr>
              <a:t>on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omosome 4.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e minimum number for the y-axis scale was the normalized average input tag count, and the maximum number was the averaged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ChIP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tag count (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9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able). The WIG file for IGB was provided in GEO databas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accession number </a:t>
            </a:r>
            <a:r>
              <a:rPr lang="en-US" sz="1000" dirty="0" smtClean="0"/>
              <a:t>GSE228846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0" y="959905"/>
            <a:ext cx="170475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50A2.3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70801" y="3600787"/>
            <a:ext cx="121477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23H5.11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115875" y="6257811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23H5.8</a:t>
            </a:r>
            <a:endParaRPr lang="en-US" sz="1000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93" y="1254727"/>
            <a:ext cx="4867692" cy="2332308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2468203" y="2835477"/>
            <a:ext cx="87504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50A2.3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315" y="3848296"/>
            <a:ext cx="4867692" cy="2332308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>
            <a:off x="2599039" y="5434575"/>
            <a:ext cx="10595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23H5.11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7315" y="6622176"/>
            <a:ext cx="4867692" cy="2332308"/>
          </a:xfrm>
          <a:prstGeom prst="rect">
            <a:avLst/>
          </a:prstGeom>
        </p:spPr>
      </p:pic>
      <p:sp>
        <p:nvSpPr>
          <p:cNvPr id="43" name="TextBox 42"/>
          <p:cNvSpPr txBox="1"/>
          <p:nvPr/>
        </p:nvSpPr>
        <p:spPr>
          <a:xfrm>
            <a:off x="2196755" y="8076155"/>
            <a:ext cx="10595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23H5.8</a:t>
            </a:r>
          </a:p>
        </p:txBody>
      </p:sp>
      <p:grpSp>
        <p:nvGrpSpPr>
          <p:cNvPr id="27" name="Group 26"/>
          <p:cNvGrpSpPr/>
          <p:nvPr/>
        </p:nvGrpSpPr>
        <p:grpSpPr>
          <a:xfrm>
            <a:off x="313660" y="1206015"/>
            <a:ext cx="1152195" cy="1421772"/>
            <a:chOff x="470526" y="6079802"/>
            <a:chExt cx="1152195" cy="1421772"/>
          </a:xfrm>
        </p:grpSpPr>
        <p:sp>
          <p:nvSpPr>
            <p:cNvPr id="28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Group 36"/>
          <p:cNvGrpSpPr/>
          <p:nvPr/>
        </p:nvGrpSpPr>
        <p:grpSpPr>
          <a:xfrm>
            <a:off x="363090" y="3847008"/>
            <a:ext cx="1152195" cy="1421772"/>
            <a:chOff x="470526" y="6079802"/>
            <a:chExt cx="1152195" cy="1421772"/>
          </a:xfrm>
        </p:grpSpPr>
        <p:sp>
          <p:nvSpPr>
            <p:cNvPr id="47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1" name="Group 50"/>
          <p:cNvGrpSpPr/>
          <p:nvPr/>
        </p:nvGrpSpPr>
        <p:grpSpPr>
          <a:xfrm>
            <a:off x="363089" y="6679642"/>
            <a:ext cx="1152195" cy="1421772"/>
            <a:chOff x="470526" y="6079802"/>
            <a:chExt cx="1152195" cy="1421772"/>
          </a:xfrm>
        </p:grpSpPr>
        <p:sp>
          <p:nvSpPr>
            <p:cNvPr id="52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86297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D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egrh-3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7" y="2645167"/>
            <a:ext cx="11398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94H6A.5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F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08F11.1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879" y="285904"/>
            <a:ext cx="4867692" cy="2332308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2107260" y="1837963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egrh-3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879" y="2918343"/>
            <a:ext cx="4867692" cy="2332308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2238153" y="4785855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94H6A.5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904" y="5645962"/>
            <a:ext cx="4867692" cy="2332308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2450400" y="7391420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08F11.1</a:t>
            </a:r>
          </a:p>
        </p:txBody>
      </p:sp>
      <p:grpSp>
        <p:nvGrpSpPr>
          <p:cNvPr id="34" name="Group 33"/>
          <p:cNvGrpSpPr/>
          <p:nvPr/>
        </p:nvGrpSpPr>
        <p:grpSpPr>
          <a:xfrm>
            <a:off x="232904" y="280792"/>
            <a:ext cx="1152195" cy="1421772"/>
            <a:chOff x="470526" y="6079802"/>
            <a:chExt cx="1152195" cy="1421772"/>
          </a:xfrm>
        </p:grpSpPr>
        <p:sp>
          <p:nvSpPr>
            <p:cNvPr id="38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4" name="Group 43"/>
          <p:cNvGrpSpPr/>
          <p:nvPr/>
        </p:nvGrpSpPr>
        <p:grpSpPr>
          <a:xfrm>
            <a:off x="268337" y="2891388"/>
            <a:ext cx="1152195" cy="1421772"/>
            <a:chOff x="470526" y="6079802"/>
            <a:chExt cx="1152195" cy="1421772"/>
          </a:xfrm>
        </p:grpSpPr>
        <p:sp>
          <p:nvSpPr>
            <p:cNvPr id="45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9" name="Group 48"/>
          <p:cNvGrpSpPr/>
          <p:nvPr/>
        </p:nvGrpSpPr>
        <p:grpSpPr>
          <a:xfrm>
            <a:off x="380832" y="5612825"/>
            <a:ext cx="1152195" cy="1421772"/>
            <a:chOff x="470526" y="6079802"/>
            <a:chExt cx="1152195" cy="1421772"/>
          </a:xfrm>
        </p:grpSpPr>
        <p:sp>
          <p:nvSpPr>
            <p:cNvPr id="5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9623467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G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pl-2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H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08B6.9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I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oat-1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103" y="263748"/>
            <a:ext cx="4867692" cy="2332308"/>
          </a:xfrm>
          <a:prstGeom prst="rect">
            <a:avLst/>
          </a:prstGeom>
        </p:spPr>
      </p:pic>
      <p:sp>
        <p:nvSpPr>
          <p:cNvPr id="29" name="TextBox 28"/>
          <p:cNvSpPr txBox="1"/>
          <p:nvPr/>
        </p:nvSpPr>
        <p:spPr>
          <a:xfrm>
            <a:off x="2009041" y="1916631"/>
            <a:ext cx="1249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pl-20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103" y="2918288"/>
            <a:ext cx="4867692" cy="2332308"/>
          </a:xfrm>
          <a:prstGeom prst="rect">
            <a:avLst/>
          </a:prstGeom>
        </p:spPr>
      </p:pic>
      <p:sp>
        <p:nvSpPr>
          <p:cNvPr id="30" name="TextBox 29"/>
          <p:cNvSpPr txBox="1"/>
          <p:nvPr/>
        </p:nvSpPr>
        <p:spPr>
          <a:xfrm>
            <a:off x="278739" y="4807130"/>
            <a:ext cx="70376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08B6.9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660" y="5686477"/>
            <a:ext cx="4867692" cy="2332308"/>
          </a:xfrm>
          <a:prstGeom prst="rect">
            <a:avLst/>
          </a:prstGeom>
        </p:spPr>
      </p:pic>
      <p:sp>
        <p:nvSpPr>
          <p:cNvPr id="32" name="TextBox 31"/>
          <p:cNvSpPr txBox="1"/>
          <p:nvPr/>
        </p:nvSpPr>
        <p:spPr>
          <a:xfrm>
            <a:off x="2169041" y="7550370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oat-1</a:t>
            </a:r>
          </a:p>
        </p:txBody>
      </p:sp>
      <p:grpSp>
        <p:nvGrpSpPr>
          <p:cNvPr id="31" name="Group 30"/>
          <p:cNvGrpSpPr/>
          <p:nvPr/>
        </p:nvGrpSpPr>
        <p:grpSpPr>
          <a:xfrm>
            <a:off x="275033" y="258636"/>
            <a:ext cx="1152195" cy="1421772"/>
            <a:chOff x="470526" y="6079802"/>
            <a:chExt cx="1152195" cy="1421772"/>
          </a:xfrm>
        </p:grpSpPr>
        <p:sp>
          <p:nvSpPr>
            <p:cNvPr id="37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289475" y="2873799"/>
            <a:ext cx="1152195" cy="1421772"/>
            <a:chOff x="470526" y="6079802"/>
            <a:chExt cx="1152195" cy="1421772"/>
          </a:xfrm>
        </p:grpSpPr>
        <p:sp>
          <p:nvSpPr>
            <p:cNvPr id="46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36362" y="5659770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47486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J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46C2.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K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mbf-1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7" y="5397434"/>
            <a:ext cx="956930" cy="2485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L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eri-12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782" y="235026"/>
            <a:ext cx="4867692" cy="2332308"/>
          </a:xfrm>
          <a:prstGeom prst="rect">
            <a:avLst/>
          </a:prstGeom>
        </p:spPr>
      </p:pic>
      <p:sp>
        <p:nvSpPr>
          <p:cNvPr id="45" name="TextBox 44"/>
          <p:cNvSpPr txBox="1"/>
          <p:nvPr/>
        </p:nvSpPr>
        <p:spPr>
          <a:xfrm>
            <a:off x="763206" y="2092743"/>
            <a:ext cx="7307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46C2.5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2782" y="2907375"/>
            <a:ext cx="4867692" cy="2332308"/>
          </a:xfrm>
          <a:prstGeom prst="rect">
            <a:avLst/>
          </a:prstGeom>
        </p:spPr>
      </p:pic>
      <p:sp>
        <p:nvSpPr>
          <p:cNvPr id="46" name="TextBox 45"/>
          <p:cNvSpPr txBox="1"/>
          <p:nvPr/>
        </p:nvSpPr>
        <p:spPr>
          <a:xfrm>
            <a:off x="2307661" y="4773739"/>
            <a:ext cx="87938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mbf-1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9034" y="5652632"/>
            <a:ext cx="4867692" cy="2332308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3952966" y="7531661"/>
            <a:ext cx="66466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eri-12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255819" y="227553"/>
            <a:ext cx="1152195" cy="1421772"/>
            <a:chOff x="470526" y="6079802"/>
            <a:chExt cx="1152195" cy="1421772"/>
          </a:xfrm>
        </p:grpSpPr>
        <p:sp>
          <p:nvSpPr>
            <p:cNvPr id="3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8" name="Group 37"/>
          <p:cNvGrpSpPr/>
          <p:nvPr/>
        </p:nvGrpSpPr>
        <p:grpSpPr>
          <a:xfrm>
            <a:off x="302248" y="2907375"/>
            <a:ext cx="1152195" cy="1421772"/>
            <a:chOff x="470526" y="6079802"/>
            <a:chExt cx="1152195" cy="1421772"/>
          </a:xfrm>
        </p:grpSpPr>
        <p:sp>
          <p:nvSpPr>
            <p:cNvPr id="4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36362" y="5622868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026823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M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ga-5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N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sqrd-1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6" y="5397434"/>
            <a:ext cx="11374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O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57G11A.4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406" y="272561"/>
            <a:ext cx="4867692" cy="2332308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832026" y="1855940"/>
            <a:ext cx="784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rga-5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406" y="2891388"/>
            <a:ext cx="4867692" cy="2332308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2215116" y="4728118"/>
            <a:ext cx="7964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sqrd-1</a:t>
            </a: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3406" y="5754914"/>
            <a:ext cx="4867692" cy="2332308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3713262" y="7629776"/>
            <a:ext cx="881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57G11A.4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302248" y="260430"/>
            <a:ext cx="1152195" cy="1421772"/>
            <a:chOff x="470526" y="6079802"/>
            <a:chExt cx="1152195" cy="1421772"/>
          </a:xfrm>
        </p:grpSpPr>
        <p:sp>
          <p:nvSpPr>
            <p:cNvPr id="3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302663" y="2888070"/>
            <a:ext cx="1152195" cy="1421772"/>
            <a:chOff x="470526" y="6079802"/>
            <a:chExt cx="1152195" cy="1421772"/>
          </a:xfrm>
        </p:grpSpPr>
        <p:sp>
          <p:nvSpPr>
            <p:cNvPr id="46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36362" y="5754914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681622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P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41E3.13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Q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40H7A.4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6" y="5397434"/>
            <a:ext cx="11374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R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73F8A.20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904" y="228685"/>
            <a:ext cx="4867692" cy="2332308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2093666" y="2075859"/>
            <a:ext cx="784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41E3.13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904" y="2834371"/>
            <a:ext cx="4867692" cy="2332308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3233688" y="4427176"/>
            <a:ext cx="79643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40H7A.4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904" y="5726204"/>
            <a:ext cx="4867692" cy="2332308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4361444" y="7595052"/>
            <a:ext cx="881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73F8A.20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336362" y="207839"/>
            <a:ext cx="1152195" cy="1421772"/>
            <a:chOff x="470526" y="6079802"/>
            <a:chExt cx="1152195" cy="1421772"/>
          </a:xfrm>
        </p:grpSpPr>
        <p:sp>
          <p:nvSpPr>
            <p:cNvPr id="3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336362" y="2834371"/>
            <a:ext cx="1152195" cy="1421772"/>
            <a:chOff x="470526" y="6079802"/>
            <a:chExt cx="1152195" cy="1421772"/>
          </a:xfrm>
        </p:grpSpPr>
        <p:sp>
          <p:nvSpPr>
            <p:cNvPr id="46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36362" y="5721662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181292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S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ari-1.4/tag-349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T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105C5B.5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6" y="5397434"/>
            <a:ext cx="11374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U) 21ur-203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581" y="216345"/>
            <a:ext cx="4867692" cy="2332308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1011361" y="1683889"/>
            <a:ext cx="784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ari-1.4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306" y="2915310"/>
            <a:ext cx="4867692" cy="2332308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4067500" y="4649865"/>
            <a:ext cx="9447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105C5B.5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479" y="5724649"/>
            <a:ext cx="4867692" cy="2332308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2382173" y="7456156"/>
            <a:ext cx="88188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1ur-2039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9" name="Group 28"/>
          <p:cNvGrpSpPr/>
          <p:nvPr/>
        </p:nvGrpSpPr>
        <p:grpSpPr>
          <a:xfrm>
            <a:off x="302248" y="179751"/>
            <a:ext cx="1152195" cy="1421772"/>
            <a:chOff x="470526" y="6079802"/>
            <a:chExt cx="1152195" cy="1421772"/>
          </a:xfrm>
        </p:grpSpPr>
        <p:sp>
          <p:nvSpPr>
            <p:cNvPr id="3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302247" y="2880217"/>
            <a:ext cx="1152195" cy="1421772"/>
            <a:chOff x="470526" y="6079802"/>
            <a:chExt cx="1152195" cy="1421772"/>
          </a:xfrm>
        </p:grpSpPr>
        <p:sp>
          <p:nvSpPr>
            <p:cNvPr id="46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36362" y="5724649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9460169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0" y="17527"/>
            <a:ext cx="140349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V)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sta-1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37856" y="2645167"/>
            <a:ext cx="145070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W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116A8A.150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86706" y="5397434"/>
            <a:ext cx="113745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X)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116A8C.25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543" y="275830"/>
            <a:ext cx="4867692" cy="2332308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659712" y="1855940"/>
            <a:ext cx="78427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sta-1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543" y="2887558"/>
            <a:ext cx="4867692" cy="2332308"/>
          </a:xfrm>
          <a:prstGeom prst="rect">
            <a:avLst/>
          </a:prstGeom>
        </p:spPr>
      </p:pic>
      <p:sp>
        <p:nvSpPr>
          <p:cNvPr id="40" name="TextBox 39"/>
          <p:cNvSpPr txBox="1"/>
          <p:nvPr/>
        </p:nvSpPr>
        <p:spPr>
          <a:xfrm>
            <a:off x="1403498" y="4612371"/>
            <a:ext cx="10952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116A8A.150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4244" y="5670520"/>
            <a:ext cx="4867692" cy="2332308"/>
          </a:xfrm>
          <a:prstGeom prst="rect">
            <a:avLst/>
          </a:prstGeom>
        </p:spPr>
      </p:pic>
      <p:sp>
        <p:nvSpPr>
          <p:cNvPr id="44" name="TextBox 43"/>
          <p:cNvSpPr txBox="1"/>
          <p:nvPr/>
        </p:nvSpPr>
        <p:spPr>
          <a:xfrm>
            <a:off x="2335875" y="7133515"/>
            <a:ext cx="9281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Y116A8C.25</a:t>
            </a:r>
          </a:p>
        </p:txBody>
      </p:sp>
      <p:grpSp>
        <p:nvGrpSpPr>
          <p:cNvPr id="29" name="Group 28"/>
          <p:cNvGrpSpPr/>
          <p:nvPr/>
        </p:nvGrpSpPr>
        <p:grpSpPr>
          <a:xfrm>
            <a:off x="302248" y="256600"/>
            <a:ext cx="1152195" cy="1421772"/>
            <a:chOff x="470526" y="6079802"/>
            <a:chExt cx="1152195" cy="1421772"/>
          </a:xfrm>
        </p:grpSpPr>
        <p:sp>
          <p:nvSpPr>
            <p:cNvPr id="30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5" name="Group 44"/>
          <p:cNvGrpSpPr/>
          <p:nvPr/>
        </p:nvGrpSpPr>
        <p:grpSpPr>
          <a:xfrm>
            <a:off x="291790" y="2860693"/>
            <a:ext cx="1152195" cy="1421772"/>
            <a:chOff x="470526" y="6079802"/>
            <a:chExt cx="1152195" cy="1421772"/>
          </a:xfrm>
        </p:grpSpPr>
        <p:sp>
          <p:nvSpPr>
            <p:cNvPr id="46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 49"/>
          <p:cNvGrpSpPr/>
          <p:nvPr/>
        </p:nvGrpSpPr>
        <p:grpSpPr>
          <a:xfrm>
            <a:off x="336362" y="5633643"/>
            <a:ext cx="1152195" cy="1421772"/>
            <a:chOff x="470526" y="6079802"/>
            <a:chExt cx="1152195" cy="1421772"/>
          </a:xfrm>
        </p:grpSpPr>
        <p:sp>
          <p:nvSpPr>
            <p:cNvPr id="51" name="TextBox 43"/>
            <p:cNvSpPr txBox="1"/>
            <p:nvPr/>
          </p:nvSpPr>
          <p:spPr>
            <a:xfrm>
              <a:off x="470526" y="6079802"/>
              <a:ext cx="1053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TextBox 44"/>
            <p:cNvSpPr txBox="1"/>
            <p:nvPr/>
          </p:nvSpPr>
          <p:spPr>
            <a:xfrm>
              <a:off x="470526" y="6885548"/>
              <a:ext cx="115219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put_Bio</a:t>
              </a:r>
              <a:r>
                <a:rPr lang="en-US" sz="1000" dirty="0" smtClean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TextBox 45"/>
            <p:cNvSpPr txBox="1"/>
            <p:nvPr/>
          </p:nvSpPr>
          <p:spPr>
            <a:xfrm>
              <a:off x="470527" y="6449607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1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TextBox 46"/>
            <p:cNvSpPr txBox="1"/>
            <p:nvPr/>
          </p:nvSpPr>
          <p:spPr>
            <a:xfrm>
              <a:off x="470527" y="7255353"/>
              <a:ext cx="97988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000" dirty="0" err="1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P_Bio</a:t>
              </a:r>
              <a:r>
                <a:rPr lang="en-US" sz="1000" dirty="0" smtClean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rep2</a:t>
              </a:r>
              <a:endParaRPr lang="en-US" sz="10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9793663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3</TotalTime>
  <Words>369</Words>
  <Application>Microsoft Office PowerPoint</Application>
  <PresentationFormat>On-screen Show (4:3)</PresentationFormat>
  <Paragraphs>145</Paragraphs>
  <Slides>8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SimSun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ingxia</dc:creator>
  <cp:lastModifiedBy>Dingxia</cp:lastModifiedBy>
  <cp:revision>52</cp:revision>
  <cp:lastPrinted>2023-01-23T06:24:09Z</cp:lastPrinted>
  <dcterms:created xsi:type="dcterms:W3CDTF">2023-01-23T06:15:50Z</dcterms:created>
  <dcterms:modified xsi:type="dcterms:W3CDTF">2023-10-23T07:44:37Z</dcterms:modified>
</cp:coreProperties>
</file>